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99" r:id="rId2"/>
    <p:sldId id="300" r:id="rId3"/>
  </p:sldIdLst>
  <p:sldSz cx="6858000" cy="9906000" type="A4"/>
  <p:notesSz cx="6797675" cy="9926638"/>
  <p:defaultTextStyle>
    <a:defPPr>
      <a:defRPr lang="fr-FR"/>
    </a:defPPr>
    <a:lvl1pPr marL="0" algn="l" defTabSz="1072866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1pPr>
    <a:lvl2pPr marL="536433" algn="l" defTabSz="1072866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2pPr>
    <a:lvl3pPr marL="1072866" algn="l" defTabSz="1072866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3pPr>
    <a:lvl4pPr marL="1609298" algn="l" defTabSz="1072866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4pPr>
    <a:lvl5pPr marL="2145731" algn="l" defTabSz="1072866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5pPr>
    <a:lvl6pPr marL="2682164" algn="l" defTabSz="1072866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6pPr>
    <a:lvl7pPr marL="3218597" algn="l" defTabSz="1072866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7pPr>
    <a:lvl8pPr marL="3755029" algn="l" defTabSz="1072866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8pPr>
    <a:lvl9pPr marL="4291462" algn="l" defTabSz="1072866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lisa derosa" initials="ld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9D9D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5728" autoAdjust="0"/>
  </p:normalViewPr>
  <p:slideViewPr>
    <p:cSldViewPr>
      <p:cViewPr varScale="1">
        <p:scale>
          <a:sx n="60" d="100"/>
          <a:sy n="60" d="100"/>
        </p:scale>
        <p:origin x="2530" y="43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051C314-B8F0-489E-87C5-9A48A7CB80EC}" type="datetimeFigureOut">
              <a:rPr lang="fr-FR" smtClean="0"/>
              <a:t>23/01/2021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09788" y="744538"/>
            <a:ext cx="25781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59DF1A4-ED9C-4946-8CB0-4C4D7277A1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156236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72866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1pPr>
    <a:lvl2pPr marL="536433" algn="l" defTabSz="1072866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2pPr>
    <a:lvl3pPr marL="1072866" algn="l" defTabSz="1072866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3pPr>
    <a:lvl4pPr marL="1609298" algn="l" defTabSz="1072866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4pPr>
    <a:lvl5pPr marL="2145731" algn="l" defTabSz="1072866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5pPr>
    <a:lvl6pPr marL="2682164" algn="l" defTabSz="1072866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6pPr>
    <a:lvl7pPr marL="3218597" algn="l" defTabSz="1072866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7pPr>
    <a:lvl8pPr marL="3755029" algn="l" defTabSz="1072866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8pPr>
    <a:lvl9pPr marL="4291462" algn="l" defTabSz="1072866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109788" y="744538"/>
            <a:ext cx="2578100" cy="3722687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noProof="0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59DF1A4-ED9C-4946-8CB0-4C4D7277A182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3694948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90"/>
            <a:ext cx="5829300" cy="2123369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363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727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60909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1454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68182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2181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7545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29092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DC8B0-F81D-459E-ABA8-65BDE9825C0B}" type="datetimeFigureOut">
              <a:rPr lang="fr-FR" smtClean="0"/>
              <a:t>23/01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B2569-D566-4A2B-9AA9-F52D0DAE13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912406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DC8B0-F81D-459E-ABA8-65BDE9825C0B}" type="datetimeFigureOut">
              <a:rPr lang="fr-FR" smtClean="0"/>
              <a:t>23/01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B2569-D566-4A2B-9AA9-F52D0DAE13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191396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9" y="529703"/>
            <a:ext cx="1157289" cy="11268075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8" y="529703"/>
            <a:ext cx="3357564" cy="11268075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DC8B0-F81D-459E-ABA8-65BDE9825C0B}" type="datetimeFigureOut">
              <a:rPr lang="fr-FR" smtClean="0"/>
              <a:t>23/01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B2569-D566-4A2B-9AA9-F52D0DAE13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109983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DC8B0-F81D-459E-ABA8-65BDE9825C0B}" type="datetimeFigureOut">
              <a:rPr lang="fr-FR" smtClean="0"/>
              <a:t>23/01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B2569-D566-4A2B-9AA9-F52D0DAE13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736140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700" b="1" cap="all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93"/>
            <a:ext cx="5829300" cy="2166937"/>
          </a:xfrm>
        </p:spPr>
        <p:txBody>
          <a:bodyPr anchor="b"/>
          <a:lstStyle>
            <a:lvl1pPr marL="0" indent="0">
              <a:buNone/>
              <a:defRPr sz="2299">
                <a:solidFill>
                  <a:schemeClr val="tx1">
                    <a:tint val="75000"/>
                  </a:schemeClr>
                </a:solidFill>
              </a:defRPr>
            </a:lvl1pPr>
            <a:lvl2pPr marL="536366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1072731" indent="0">
              <a:buNone/>
              <a:defRPr sz="1899">
                <a:solidFill>
                  <a:schemeClr val="tx1">
                    <a:tint val="75000"/>
                  </a:schemeClr>
                </a:solidFill>
              </a:defRPr>
            </a:lvl3pPr>
            <a:lvl4pPr marL="160909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214546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68182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321819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75455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429092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DC8B0-F81D-459E-ABA8-65BDE9825C0B}" type="datetimeFigureOut">
              <a:rPr lang="fr-FR" smtClean="0"/>
              <a:t>23/01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B2569-D566-4A2B-9AA9-F52D0DAE13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469948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9" y="3081868"/>
            <a:ext cx="2257425" cy="8715905"/>
          </a:xfrm>
        </p:spPr>
        <p:txBody>
          <a:bodyPr/>
          <a:lstStyle>
            <a:lvl1pPr>
              <a:defRPr sz="3300"/>
            </a:lvl1pPr>
            <a:lvl2pPr>
              <a:defRPr sz="2799"/>
            </a:lvl2pPr>
            <a:lvl3pPr>
              <a:defRPr sz="2299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4" y="3081868"/>
            <a:ext cx="2257425" cy="8715905"/>
          </a:xfrm>
        </p:spPr>
        <p:txBody>
          <a:bodyPr/>
          <a:lstStyle>
            <a:lvl1pPr>
              <a:defRPr sz="3300"/>
            </a:lvl1pPr>
            <a:lvl2pPr>
              <a:defRPr sz="2799"/>
            </a:lvl2pPr>
            <a:lvl3pPr>
              <a:defRPr sz="2299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DC8B0-F81D-459E-ABA8-65BDE9825C0B}" type="datetimeFigureOut">
              <a:rPr lang="fr-FR" smtClean="0"/>
              <a:t>23/01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B2569-D566-4A2B-9AA9-F52D0DAE13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900571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6701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1" y="2217386"/>
            <a:ext cx="3030141" cy="924102"/>
          </a:xfrm>
        </p:spPr>
        <p:txBody>
          <a:bodyPr anchor="b"/>
          <a:lstStyle>
            <a:lvl1pPr marL="0" indent="0">
              <a:buNone/>
              <a:defRPr sz="2799" b="1"/>
            </a:lvl1pPr>
            <a:lvl2pPr marL="536366" indent="0">
              <a:buNone/>
              <a:defRPr sz="2299" b="1"/>
            </a:lvl2pPr>
            <a:lvl3pPr marL="1072731" indent="0">
              <a:buNone/>
              <a:defRPr sz="2100" b="1"/>
            </a:lvl3pPr>
            <a:lvl4pPr marL="1609096" indent="0">
              <a:buNone/>
              <a:defRPr sz="1899" b="1"/>
            </a:lvl4pPr>
            <a:lvl5pPr marL="2145462" indent="0">
              <a:buNone/>
              <a:defRPr sz="1899" b="1"/>
            </a:lvl5pPr>
            <a:lvl6pPr marL="2681826" indent="0">
              <a:buNone/>
              <a:defRPr sz="1899" b="1"/>
            </a:lvl6pPr>
            <a:lvl7pPr marL="3218193" indent="0">
              <a:buNone/>
              <a:defRPr sz="1899" b="1"/>
            </a:lvl7pPr>
            <a:lvl8pPr marL="3754558" indent="0">
              <a:buNone/>
              <a:defRPr sz="1899" b="1"/>
            </a:lvl8pPr>
            <a:lvl9pPr marL="4290922" indent="0">
              <a:buNone/>
              <a:defRPr sz="1899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799"/>
            </a:lvl1pPr>
            <a:lvl2pPr>
              <a:defRPr sz="2299"/>
            </a:lvl2pPr>
            <a:lvl3pPr>
              <a:defRPr sz="2100"/>
            </a:lvl3pPr>
            <a:lvl4pPr>
              <a:defRPr sz="1899"/>
            </a:lvl4pPr>
            <a:lvl5pPr>
              <a:defRPr sz="1899"/>
            </a:lvl5pPr>
            <a:lvl6pPr>
              <a:defRPr sz="1899"/>
            </a:lvl6pPr>
            <a:lvl7pPr>
              <a:defRPr sz="1899"/>
            </a:lvl7pPr>
            <a:lvl8pPr>
              <a:defRPr sz="1899"/>
            </a:lvl8pPr>
            <a:lvl9pPr>
              <a:defRPr sz="1899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0" y="2217386"/>
            <a:ext cx="3031332" cy="924102"/>
          </a:xfrm>
        </p:spPr>
        <p:txBody>
          <a:bodyPr anchor="b"/>
          <a:lstStyle>
            <a:lvl1pPr marL="0" indent="0">
              <a:buNone/>
              <a:defRPr sz="2799" b="1"/>
            </a:lvl1pPr>
            <a:lvl2pPr marL="536366" indent="0">
              <a:buNone/>
              <a:defRPr sz="2299" b="1"/>
            </a:lvl2pPr>
            <a:lvl3pPr marL="1072731" indent="0">
              <a:buNone/>
              <a:defRPr sz="2100" b="1"/>
            </a:lvl3pPr>
            <a:lvl4pPr marL="1609096" indent="0">
              <a:buNone/>
              <a:defRPr sz="1899" b="1"/>
            </a:lvl4pPr>
            <a:lvl5pPr marL="2145462" indent="0">
              <a:buNone/>
              <a:defRPr sz="1899" b="1"/>
            </a:lvl5pPr>
            <a:lvl6pPr marL="2681826" indent="0">
              <a:buNone/>
              <a:defRPr sz="1899" b="1"/>
            </a:lvl6pPr>
            <a:lvl7pPr marL="3218193" indent="0">
              <a:buNone/>
              <a:defRPr sz="1899" b="1"/>
            </a:lvl7pPr>
            <a:lvl8pPr marL="3754558" indent="0">
              <a:buNone/>
              <a:defRPr sz="1899" b="1"/>
            </a:lvl8pPr>
            <a:lvl9pPr marL="4290922" indent="0">
              <a:buNone/>
              <a:defRPr sz="1899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2" cy="5707416"/>
          </a:xfrm>
        </p:spPr>
        <p:txBody>
          <a:bodyPr/>
          <a:lstStyle>
            <a:lvl1pPr>
              <a:defRPr sz="2799"/>
            </a:lvl1pPr>
            <a:lvl2pPr>
              <a:defRPr sz="2299"/>
            </a:lvl2pPr>
            <a:lvl3pPr>
              <a:defRPr sz="2100"/>
            </a:lvl3pPr>
            <a:lvl4pPr>
              <a:defRPr sz="1899"/>
            </a:lvl4pPr>
            <a:lvl5pPr>
              <a:defRPr sz="1899"/>
            </a:lvl5pPr>
            <a:lvl6pPr>
              <a:defRPr sz="1899"/>
            </a:lvl6pPr>
            <a:lvl7pPr>
              <a:defRPr sz="1899"/>
            </a:lvl7pPr>
            <a:lvl8pPr>
              <a:defRPr sz="1899"/>
            </a:lvl8pPr>
            <a:lvl9pPr>
              <a:defRPr sz="1899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DC8B0-F81D-459E-ABA8-65BDE9825C0B}" type="datetimeFigureOut">
              <a:rPr lang="fr-FR" smtClean="0"/>
              <a:t>23/01/20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B2569-D566-4A2B-9AA9-F52D0DAE13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377314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DC8B0-F81D-459E-ABA8-65BDE9825C0B}" type="datetimeFigureOut">
              <a:rPr lang="fr-FR" smtClean="0"/>
              <a:t>23/01/20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B2569-D566-4A2B-9AA9-F52D0DAE13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723419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DC8B0-F81D-459E-ABA8-65BDE9825C0B}" type="datetimeFigureOut">
              <a:rPr lang="fr-FR" smtClean="0"/>
              <a:t>23/01/20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B2569-D566-4A2B-9AA9-F52D0DAE13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16134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3" y="394406"/>
            <a:ext cx="2256235" cy="1678518"/>
          </a:xfrm>
        </p:spPr>
        <p:txBody>
          <a:bodyPr anchor="b"/>
          <a:lstStyle>
            <a:lvl1pPr algn="l">
              <a:defRPr sz="2299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90" y="394415"/>
            <a:ext cx="3833813" cy="8454497"/>
          </a:xfrm>
        </p:spPr>
        <p:txBody>
          <a:bodyPr/>
          <a:lstStyle>
            <a:lvl1pPr>
              <a:defRPr sz="3800"/>
            </a:lvl1pPr>
            <a:lvl2pPr>
              <a:defRPr sz="3300"/>
            </a:lvl2pPr>
            <a:lvl3pPr>
              <a:defRPr sz="2799"/>
            </a:lvl3pPr>
            <a:lvl4pPr>
              <a:defRPr sz="2299"/>
            </a:lvl4pPr>
            <a:lvl5pPr>
              <a:defRPr sz="2299"/>
            </a:lvl5pPr>
            <a:lvl6pPr>
              <a:defRPr sz="2299"/>
            </a:lvl6pPr>
            <a:lvl7pPr>
              <a:defRPr sz="2299"/>
            </a:lvl7pPr>
            <a:lvl8pPr>
              <a:defRPr sz="2299"/>
            </a:lvl8pPr>
            <a:lvl9pPr>
              <a:defRPr sz="2299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3" y="2072927"/>
            <a:ext cx="2256235" cy="6775980"/>
          </a:xfrm>
        </p:spPr>
        <p:txBody>
          <a:bodyPr/>
          <a:lstStyle>
            <a:lvl1pPr marL="0" indent="0">
              <a:buNone/>
              <a:defRPr sz="1600"/>
            </a:lvl1pPr>
            <a:lvl2pPr marL="536366" indent="0">
              <a:buNone/>
              <a:defRPr sz="1400"/>
            </a:lvl2pPr>
            <a:lvl3pPr marL="1072731" indent="0">
              <a:buNone/>
              <a:defRPr sz="1200"/>
            </a:lvl3pPr>
            <a:lvl4pPr marL="1609096" indent="0">
              <a:buNone/>
              <a:defRPr sz="1101"/>
            </a:lvl4pPr>
            <a:lvl5pPr marL="2145462" indent="0">
              <a:buNone/>
              <a:defRPr sz="1101"/>
            </a:lvl5pPr>
            <a:lvl6pPr marL="2681826" indent="0">
              <a:buNone/>
              <a:defRPr sz="1101"/>
            </a:lvl6pPr>
            <a:lvl7pPr marL="3218193" indent="0">
              <a:buNone/>
              <a:defRPr sz="1101"/>
            </a:lvl7pPr>
            <a:lvl8pPr marL="3754558" indent="0">
              <a:buNone/>
              <a:defRPr sz="1101"/>
            </a:lvl8pPr>
            <a:lvl9pPr marL="4290922" indent="0">
              <a:buNone/>
              <a:defRPr sz="110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DC8B0-F81D-459E-ABA8-65BDE9825C0B}" type="datetimeFigureOut">
              <a:rPr lang="fr-FR" smtClean="0"/>
              <a:t>23/01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B2569-D566-4A2B-9AA9-F52D0DAE13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765462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7"/>
            <a:ext cx="4114800" cy="818623"/>
          </a:xfrm>
        </p:spPr>
        <p:txBody>
          <a:bodyPr anchor="b"/>
          <a:lstStyle>
            <a:lvl1pPr algn="l">
              <a:defRPr sz="2299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800"/>
            </a:lvl1pPr>
            <a:lvl2pPr marL="536366" indent="0">
              <a:buNone/>
              <a:defRPr sz="3300"/>
            </a:lvl2pPr>
            <a:lvl3pPr marL="1072731" indent="0">
              <a:buNone/>
              <a:defRPr sz="2799"/>
            </a:lvl3pPr>
            <a:lvl4pPr marL="1609096" indent="0">
              <a:buNone/>
              <a:defRPr sz="2299"/>
            </a:lvl4pPr>
            <a:lvl5pPr marL="2145462" indent="0">
              <a:buNone/>
              <a:defRPr sz="2299"/>
            </a:lvl5pPr>
            <a:lvl6pPr marL="2681826" indent="0">
              <a:buNone/>
              <a:defRPr sz="2299"/>
            </a:lvl6pPr>
            <a:lvl7pPr marL="3218193" indent="0">
              <a:buNone/>
              <a:defRPr sz="2299"/>
            </a:lvl7pPr>
            <a:lvl8pPr marL="3754558" indent="0">
              <a:buNone/>
              <a:defRPr sz="2299"/>
            </a:lvl8pPr>
            <a:lvl9pPr marL="4290922" indent="0">
              <a:buNone/>
              <a:defRPr sz="2299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5"/>
            <a:ext cx="4114800" cy="1162580"/>
          </a:xfrm>
        </p:spPr>
        <p:txBody>
          <a:bodyPr/>
          <a:lstStyle>
            <a:lvl1pPr marL="0" indent="0">
              <a:buNone/>
              <a:defRPr sz="1600"/>
            </a:lvl1pPr>
            <a:lvl2pPr marL="536366" indent="0">
              <a:buNone/>
              <a:defRPr sz="1400"/>
            </a:lvl2pPr>
            <a:lvl3pPr marL="1072731" indent="0">
              <a:buNone/>
              <a:defRPr sz="1200"/>
            </a:lvl3pPr>
            <a:lvl4pPr marL="1609096" indent="0">
              <a:buNone/>
              <a:defRPr sz="1101"/>
            </a:lvl4pPr>
            <a:lvl5pPr marL="2145462" indent="0">
              <a:buNone/>
              <a:defRPr sz="1101"/>
            </a:lvl5pPr>
            <a:lvl6pPr marL="2681826" indent="0">
              <a:buNone/>
              <a:defRPr sz="1101"/>
            </a:lvl6pPr>
            <a:lvl7pPr marL="3218193" indent="0">
              <a:buNone/>
              <a:defRPr sz="1101"/>
            </a:lvl7pPr>
            <a:lvl8pPr marL="3754558" indent="0">
              <a:buNone/>
              <a:defRPr sz="1101"/>
            </a:lvl8pPr>
            <a:lvl9pPr marL="4290922" indent="0">
              <a:buNone/>
              <a:defRPr sz="110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DC8B0-F81D-459E-ABA8-65BDE9825C0B}" type="datetimeFigureOut">
              <a:rPr lang="fr-FR" smtClean="0"/>
              <a:t>23/01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B2569-D566-4A2B-9AA9-F52D0DAE13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307734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701"/>
            <a:ext cx="6172200" cy="1651000"/>
          </a:xfrm>
          <a:prstGeom prst="rect">
            <a:avLst/>
          </a:prstGeom>
        </p:spPr>
        <p:txBody>
          <a:bodyPr vert="horz" lIns="107287" tIns="53643" rIns="107287" bIns="53643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107287" tIns="53643" rIns="107287" bIns="53643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402"/>
            <a:ext cx="1600200" cy="527403"/>
          </a:xfrm>
          <a:prstGeom prst="rect">
            <a:avLst/>
          </a:prstGeom>
        </p:spPr>
        <p:txBody>
          <a:bodyPr vert="horz" lIns="107287" tIns="53643" rIns="107287" bIns="53643" rtlCol="0" anchor="ctr"/>
          <a:lstStyle>
            <a:lvl1pPr algn="l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CDC8B0-F81D-459E-ABA8-65BDE9825C0B}" type="datetimeFigureOut">
              <a:rPr lang="fr-FR" smtClean="0"/>
              <a:t>23/01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402"/>
            <a:ext cx="2171700" cy="527403"/>
          </a:xfrm>
          <a:prstGeom prst="rect">
            <a:avLst/>
          </a:prstGeom>
        </p:spPr>
        <p:txBody>
          <a:bodyPr vert="horz" lIns="107287" tIns="53643" rIns="107287" bIns="53643" rtlCol="0" anchor="ctr"/>
          <a:lstStyle>
            <a:lvl1pPr algn="ct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402"/>
            <a:ext cx="1600200" cy="527403"/>
          </a:xfrm>
          <a:prstGeom prst="rect">
            <a:avLst/>
          </a:prstGeom>
        </p:spPr>
        <p:txBody>
          <a:bodyPr vert="horz" lIns="107287" tIns="53643" rIns="107287" bIns="53643" rtlCol="0" anchor="ctr"/>
          <a:lstStyle>
            <a:lvl1pPr algn="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5B2569-D566-4A2B-9AA9-F52D0DAE13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54660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72731" rtl="0" eaLnBrk="1" latinLnBrk="0" hangingPunct="1">
        <a:spcBef>
          <a:spcPct val="0"/>
        </a:spcBef>
        <a:buNone/>
        <a:defRPr sz="5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2275" indent="-402275" algn="l" defTabSz="1072731" rtl="0" eaLnBrk="1" latinLnBrk="0" hangingPunct="1">
        <a:spcBef>
          <a:spcPct val="20000"/>
        </a:spcBef>
        <a:buFont typeface="Arial" pitchFamily="34" charset="0"/>
        <a:buChar char="•"/>
        <a:defRPr sz="3800" kern="1200">
          <a:solidFill>
            <a:schemeClr val="tx1"/>
          </a:solidFill>
          <a:latin typeface="+mn-lt"/>
          <a:ea typeface="+mn-ea"/>
          <a:cs typeface="+mn-cs"/>
        </a:defRPr>
      </a:lvl1pPr>
      <a:lvl2pPr marL="871595" indent="-335227" algn="l" defTabSz="1072731" rtl="0" eaLnBrk="1" latinLnBrk="0" hangingPunct="1">
        <a:spcBef>
          <a:spcPct val="20000"/>
        </a:spcBef>
        <a:buFont typeface="Arial" pitchFamily="34" charset="0"/>
        <a:buChar char="–"/>
        <a:defRPr sz="3300" kern="1200">
          <a:solidFill>
            <a:schemeClr val="tx1"/>
          </a:solidFill>
          <a:latin typeface="+mn-lt"/>
          <a:ea typeface="+mn-ea"/>
          <a:cs typeface="+mn-cs"/>
        </a:defRPr>
      </a:lvl2pPr>
      <a:lvl3pPr marL="1340914" indent="-268182" algn="l" defTabSz="1072731" rtl="0" eaLnBrk="1" latinLnBrk="0" hangingPunct="1">
        <a:spcBef>
          <a:spcPct val="20000"/>
        </a:spcBef>
        <a:buFont typeface="Arial" pitchFamily="34" charset="0"/>
        <a:buChar char="•"/>
        <a:defRPr sz="2799" kern="1200">
          <a:solidFill>
            <a:schemeClr val="tx1"/>
          </a:solidFill>
          <a:latin typeface="+mn-lt"/>
          <a:ea typeface="+mn-ea"/>
          <a:cs typeface="+mn-cs"/>
        </a:defRPr>
      </a:lvl3pPr>
      <a:lvl4pPr marL="1877279" indent="-268182" algn="l" defTabSz="1072731" rtl="0" eaLnBrk="1" latinLnBrk="0" hangingPunct="1">
        <a:spcBef>
          <a:spcPct val="20000"/>
        </a:spcBef>
        <a:buFont typeface="Arial" pitchFamily="34" charset="0"/>
        <a:buChar char="–"/>
        <a:defRPr sz="2299" kern="1200">
          <a:solidFill>
            <a:schemeClr val="tx1"/>
          </a:solidFill>
          <a:latin typeface="+mn-lt"/>
          <a:ea typeface="+mn-ea"/>
          <a:cs typeface="+mn-cs"/>
        </a:defRPr>
      </a:lvl4pPr>
      <a:lvl5pPr marL="2413645" indent="-268182" algn="l" defTabSz="1072731" rtl="0" eaLnBrk="1" latinLnBrk="0" hangingPunct="1">
        <a:spcBef>
          <a:spcPct val="20000"/>
        </a:spcBef>
        <a:buFont typeface="Arial" pitchFamily="34" charset="0"/>
        <a:buChar char="»"/>
        <a:defRPr sz="2299" kern="1200">
          <a:solidFill>
            <a:schemeClr val="tx1"/>
          </a:solidFill>
          <a:latin typeface="+mn-lt"/>
          <a:ea typeface="+mn-ea"/>
          <a:cs typeface="+mn-cs"/>
        </a:defRPr>
      </a:lvl5pPr>
      <a:lvl6pPr marL="2950009" indent="-268182" algn="l" defTabSz="1072731" rtl="0" eaLnBrk="1" latinLnBrk="0" hangingPunct="1">
        <a:spcBef>
          <a:spcPct val="20000"/>
        </a:spcBef>
        <a:buFont typeface="Arial" pitchFamily="34" charset="0"/>
        <a:buChar char="•"/>
        <a:defRPr sz="2299" kern="1200">
          <a:solidFill>
            <a:schemeClr val="tx1"/>
          </a:solidFill>
          <a:latin typeface="+mn-lt"/>
          <a:ea typeface="+mn-ea"/>
          <a:cs typeface="+mn-cs"/>
        </a:defRPr>
      </a:lvl6pPr>
      <a:lvl7pPr marL="3486375" indent="-268182" algn="l" defTabSz="1072731" rtl="0" eaLnBrk="1" latinLnBrk="0" hangingPunct="1">
        <a:spcBef>
          <a:spcPct val="20000"/>
        </a:spcBef>
        <a:buFont typeface="Arial" pitchFamily="34" charset="0"/>
        <a:buChar char="•"/>
        <a:defRPr sz="2299" kern="1200">
          <a:solidFill>
            <a:schemeClr val="tx1"/>
          </a:solidFill>
          <a:latin typeface="+mn-lt"/>
          <a:ea typeface="+mn-ea"/>
          <a:cs typeface="+mn-cs"/>
        </a:defRPr>
      </a:lvl7pPr>
      <a:lvl8pPr marL="4022739" indent="-268182" algn="l" defTabSz="1072731" rtl="0" eaLnBrk="1" latinLnBrk="0" hangingPunct="1">
        <a:spcBef>
          <a:spcPct val="20000"/>
        </a:spcBef>
        <a:buFont typeface="Arial" pitchFamily="34" charset="0"/>
        <a:buChar char="•"/>
        <a:defRPr sz="2299" kern="1200">
          <a:solidFill>
            <a:schemeClr val="tx1"/>
          </a:solidFill>
          <a:latin typeface="+mn-lt"/>
          <a:ea typeface="+mn-ea"/>
          <a:cs typeface="+mn-cs"/>
        </a:defRPr>
      </a:lvl8pPr>
      <a:lvl9pPr marL="4559105" indent="-268182" algn="l" defTabSz="1072731" rtl="0" eaLnBrk="1" latinLnBrk="0" hangingPunct="1">
        <a:spcBef>
          <a:spcPct val="20000"/>
        </a:spcBef>
        <a:buFont typeface="Arial" pitchFamily="34" charset="0"/>
        <a:buChar char="•"/>
        <a:defRPr sz="229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1072731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36366" algn="l" defTabSz="1072731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1072731" algn="l" defTabSz="1072731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09096" algn="l" defTabSz="1072731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145462" algn="l" defTabSz="1072731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681826" algn="l" defTabSz="1072731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218193" algn="l" defTabSz="1072731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754558" algn="l" defTabSz="1072731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290922" algn="l" defTabSz="1072731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0" y="389213"/>
            <a:ext cx="6858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able S1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linical and viral characteristics of patients COVID-19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enrolling in ONCOVID. Clinical and viral characteristics of patients COVID-19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enrolling in three French COVID-19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one Canadian cohort according to the duration of viral shedding (SVS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v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LVS).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ZoneTexte 4"/>
          <p:cNvSpPr txBox="1"/>
          <p:nvPr/>
        </p:nvSpPr>
        <p:spPr>
          <a:xfrm>
            <a:off x="0" y="8121352"/>
            <a:ext cx="6858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ZI: </a:t>
            </a:r>
            <a:r>
              <a:rPr lang="fr-FR" sz="8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zithromycin</a:t>
            </a:r>
            <a:r>
              <a:rPr lang="fr-FR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MI: Body Mass Index; </a:t>
            </a:r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F: Congestive heart failure;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OPD: Chronic Obstructive Pulmonary Disease; Ct: Cycle threshold; CR: Clinical Research; H: Hematological malignancies; DM: Diabetes mellitus; HCQ: </a:t>
            </a:r>
            <a:r>
              <a:rPr lang="fr-FR" sz="8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ydroxychloroquine</a:t>
            </a:r>
            <a:r>
              <a:rPr lang="fr-FR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</a:t>
            </a:r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HT: Hormonal therapy;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CU: Intensive Care Unit; LVS: Long Viral Shedding;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n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: not applicable; NED: No Evidence of Disease; no: number; PD: Progressive Disease; PS: Performance Status; S: Solid tumors; SD/PR: Stable Disease/Partial Response; SVS: Short Viral Shedding; TR: Translational Research; *</a:t>
            </a:r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 the 4 weeks before inclusion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tatistical analyses: Mann-Whitney</a:t>
            </a:r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, Chi-Square or Fisher’s exact tests.</a:t>
            </a:r>
          </a:p>
        </p:txBody>
      </p:sp>
      <p:graphicFrame>
        <p:nvGraphicFramePr>
          <p:cNvPr id="8" name="Table 3">
            <a:extLst>
              <a:ext uri="{FF2B5EF4-FFF2-40B4-BE49-F238E27FC236}">
                <a16:creationId xmlns:a16="http://schemas.microsoft.com/office/drawing/2014/main" id="{44E4FAB1-A73E-473E-9530-BD98A9CCCF4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44838906"/>
              </p:ext>
            </p:extLst>
          </p:nvPr>
        </p:nvGraphicFramePr>
        <p:xfrm>
          <a:off x="22500" y="1043031"/>
          <a:ext cx="6812999" cy="7078321"/>
        </p:xfrm>
        <a:graphic>
          <a:graphicData uri="http://schemas.openxmlformats.org/drawingml/2006/table">
            <a:tbl>
              <a:tblPr/>
              <a:tblGrid>
                <a:gridCol w="11590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92202">
                  <a:extLst>
                    <a:ext uri="{9D8B030D-6E8A-4147-A177-3AD203B41FA5}">
                      <a16:colId xmlns:a16="http://schemas.microsoft.com/office/drawing/2014/main" val="998469083"/>
                    </a:ext>
                  </a:extLst>
                </a:gridCol>
                <a:gridCol w="802012">
                  <a:extLst>
                    <a:ext uri="{9D8B030D-6E8A-4147-A177-3AD203B41FA5}">
                      <a16:colId xmlns:a16="http://schemas.microsoft.com/office/drawing/2014/main" val="2275575751"/>
                    </a:ext>
                  </a:extLst>
                </a:gridCol>
                <a:gridCol w="567862">
                  <a:extLst>
                    <a:ext uri="{9D8B030D-6E8A-4147-A177-3AD203B41FA5}">
                      <a16:colId xmlns:a16="http://schemas.microsoft.com/office/drawing/2014/main" val="1680577380"/>
                    </a:ext>
                  </a:extLst>
                </a:gridCol>
                <a:gridCol w="433345">
                  <a:extLst>
                    <a:ext uri="{9D8B030D-6E8A-4147-A177-3AD203B41FA5}">
                      <a16:colId xmlns:a16="http://schemas.microsoft.com/office/drawing/2014/main" val="2129753739"/>
                    </a:ext>
                  </a:extLst>
                </a:gridCol>
                <a:gridCol w="433345">
                  <a:extLst>
                    <a:ext uri="{9D8B030D-6E8A-4147-A177-3AD203B41FA5}">
                      <a16:colId xmlns:a16="http://schemas.microsoft.com/office/drawing/2014/main" val="2198652549"/>
                    </a:ext>
                  </a:extLst>
                </a:gridCol>
                <a:gridCol w="268241">
                  <a:extLst>
                    <a:ext uri="{9D8B030D-6E8A-4147-A177-3AD203B41FA5}">
                      <a16:colId xmlns:a16="http://schemas.microsoft.com/office/drawing/2014/main" val="3915122812"/>
                    </a:ext>
                  </a:extLst>
                </a:gridCol>
                <a:gridCol w="433345">
                  <a:extLst>
                    <a:ext uri="{9D8B030D-6E8A-4147-A177-3AD203B41FA5}">
                      <a16:colId xmlns:a16="http://schemas.microsoft.com/office/drawing/2014/main" val="2586140332"/>
                    </a:ext>
                  </a:extLst>
                </a:gridCol>
                <a:gridCol w="433345">
                  <a:extLst>
                    <a:ext uri="{9D8B030D-6E8A-4147-A177-3AD203B41FA5}">
                      <a16:colId xmlns:a16="http://schemas.microsoft.com/office/drawing/2014/main" val="1633645137"/>
                    </a:ext>
                  </a:extLst>
                </a:gridCol>
                <a:gridCol w="266673">
                  <a:extLst>
                    <a:ext uri="{9D8B030D-6E8A-4147-A177-3AD203B41FA5}">
                      <a16:colId xmlns:a16="http://schemas.microsoft.com/office/drawing/2014/main" val="2180033436"/>
                    </a:ext>
                  </a:extLst>
                </a:gridCol>
                <a:gridCol w="433345">
                  <a:extLst>
                    <a:ext uri="{9D8B030D-6E8A-4147-A177-3AD203B41FA5}">
                      <a16:colId xmlns:a16="http://schemas.microsoft.com/office/drawing/2014/main" val="3487545485"/>
                    </a:ext>
                  </a:extLst>
                </a:gridCol>
                <a:gridCol w="433345">
                  <a:extLst>
                    <a:ext uri="{9D8B030D-6E8A-4147-A177-3AD203B41FA5}">
                      <a16:colId xmlns:a16="http://schemas.microsoft.com/office/drawing/2014/main" val="1220913788"/>
                    </a:ext>
                  </a:extLst>
                </a:gridCol>
                <a:gridCol w="266673">
                  <a:extLst>
                    <a:ext uri="{9D8B030D-6E8A-4147-A177-3AD203B41FA5}">
                      <a16:colId xmlns:a16="http://schemas.microsoft.com/office/drawing/2014/main" val="1018707316"/>
                    </a:ext>
                  </a:extLst>
                </a:gridCol>
                <a:gridCol w="433345">
                  <a:extLst>
                    <a:ext uri="{9D8B030D-6E8A-4147-A177-3AD203B41FA5}">
                      <a16:colId xmlns:a16="http://schemas.microsoft.com/office/drawing/2014/main" val="959431850"/>
                    </a:ext>
                  </a:extLst>
                </a:gridCol>
                <a:gridCol w="433345">
                  <a:extLst>
                    <a:ext uri="{9D8B030D-6E8A-4147-A177-3AD203B41FA5}">
                      <a16:colId xmlns:a16="http://schemas.microsoft.com/office/drawing/2014/main" val="1340958929"/>
                    </a:ext>
                  </a:extLst>
                </a:gridCol>
                <a:gridCol w="266673">
                  <a:extLst>
                    <a:ext uri="{9D8B030D-6E8A-4147-A177-3AD203B41FA5}">
                      <a16:colId xmlns:a16="http://schemas.microsoft.com/office/drawing/2014/main" val="1536368791"/>
                    </a:ext>
                  </a:extLst>
                </a:gridCol>
              </a:tblGrid>
              <a:tr h="152527">
                <a:tc gridSpan="3"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212" marR="34212" marT="17107" marB="17107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marL="0" marR="0" lvl="0" indent="0" algn="ctr" defTabSz="1072866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ncer_FR1_TR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1072866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ncer_FR1_TR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1072866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gridSpan="3">
                  <a:txBody>
                    <a:bodyPr/>
                    <a:lstStyle/>
                    <a:p>
                      <a:pPr marL="0" marR="0" lvl="0" indent="0" algn="ctr" defTabSz="1072866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ncer_FR2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1072866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gridSpan="3">
                  <a:txBody>
                    <a:bodyPr/>
                    <a:lstStyle/>
                    <a:p>
                      <a:pPr marL="0" marR="0" lvl="0" indent="0" algn="ctr" defTabSz="1072866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ncer_FR1_CR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1072866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1072866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gridSpan="3">
                  <a:txBody>
                    <a:bodyPr/>
                    <a:lstStyle/>
                    <a:p>
                      <a:pPr marL="0" marR="0" lvl="0" indent="0" algn="ctr" defTabSz="1072866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ncer_CA</a:t>
                      </a:r>
                      <a:endParaRPr lang="en-US" sz="8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1072866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1072866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9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25039958"/>
                  </a:ext>
                </a:extLst>
              </a:tr>
              <a:tr h="294094">
                <a:tc gridSpan="3"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’s characteristics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212" marR="34212" marT="17107" marB="17107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 dirty="0">
                        <a:effectLst/>
                        <a:latin typeface="+mn-lt"/>
                      </a:endParaRPr>
                    </a:p>
                  </a:txBody>
                  <a:tcPr marL="34211" marR="34211" marT="17106" marB="17106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1072866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OVID-19</a:t>
                      </a:r>
                      <a:r>
                        <a:rPr lang="en-US" sz="800" b="1" i="0" u="none" strike="noStrike" kern="1200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800" b="1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marL="0" marR="0" indent="0" algn="ctr" defTabSz="1072866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n=52)</a:t>
                      </a:r>
                      <a:endParaRPr lang="en-US" sz="800" b="0" i="0" u="none" strike="noStrike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VS 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17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VS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18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VS 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90)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VS 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85)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VS 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37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VS 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9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VS 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49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VS 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17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94357318"/>
                  </a:ext>
                </a:extLst>
              </a:tr>
              <a:tr h="241687">
                <a:tc rowSpan="42"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inical</a:t>
                      </a:r>
                      <a:r>
                        <a:rPr lang="en-US" sz="800" b="1" i="0" u="none" strike="noStrike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haracteristics</a:t>
                      </a:r>
                      <a:endParaRPr lang="en-US" sz="8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1382" marR="3563" marT="3563" marB="0" vert="vert27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(year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1382" marR="3563" marT="35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</a:t>
                      </a:r>
                    </a:p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range)</a:t>
                      </a:r>
                      <a:endParaRPr lang="en-US" sz="8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31-89)</a:t>
                      </a:r>
                    </a:p>
                  </a:txBody>
                  <a:tcPr marL="3563" marR="3563" marT="9151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 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31-81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 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39-89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8</a:t>
                      </a:r>
                      <a:r>
                        <a:rPr lang="en-US" sz="800" b="0" i="1" u="none" strike="noStrike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23-94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26-98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3</a:t>
                      </a:r>
                      <a:r>
                        <a:rPr lang="en-US" sz="800" b="0" i="1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 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29-90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 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21-67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0</a:t>
                      </a:r>
                      <a:r>
                        <a:rPr lang="en-US" sz="800" b="0" i="0" u="none" strike="noStrike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</a:t>
                      </a:r>
                      <a:endParaRPr lang="en-US" sz="800" b="0" i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 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20-94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 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52-90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5</a:t>
                      </a:r>
                      <a:r>
                        <a:rPr lang="en-US" sz="800" b="0" i="0" u="none" strike="noStrike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</a:t>
                      </a:r>
                      <a:endParaRPr lang="en-US" sz="800" b="0" i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66745699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 dirty="0">
                        <a:effectLst/>
                        <a:latin typeface="+mn-lt"/>
                      </a:endParaRPr>
                    </a:p>
                  </a:txBody>
                  <a:tcPr marL="34211" marR="34211" marT="17106" marB="171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der</a:t>
                      </a:r>
                    </a:p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–no(%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212" marR="34212" marT="17107" marB="1710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 </a:t>
                      </a:r>
                      <a:endParaRPr lang="en-US" sz="8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 (37)</a:t>
                      </a:r>
                    </a:p>
                  </a:txBody>
                  <a:tcPr marL="3563" marR="3563" marT="9151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35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33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0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 (47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 (51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(54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44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0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 (57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35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16454267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male</a:t>
                      </a:r>
                      <a:endParaRPr lang="en-US" sz="8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 (63)</a:t>
                      </a:r>
                    </a:p>
                  </a:txBody>
                  <a:tcPr marL="3563" marR="3563" marT="9151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 (65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r>
                        <a:rPr lang="en-US" sz="800" b="0" i="0" u="none" strike="noStrike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67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 (53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 (49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 (46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56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 (43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r>
                        <a:rPr lang="en-US" sz="800" b="0" i="0" u="none" strike="noStrike" baseline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65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4809223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 dirty="0">
                        <a:effectLst/>
                        <a:latin typeface="+mn-lt"/>
                      </a:endParaRPr>
                    </a:p>
                  </a:txBody>
                  <a:tcPr marL="34211" marR="34211" marT="17106" marB="171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4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of comorbidities–no(%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212" marR="34212" marT="17107" marB="1710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 (40)</a:t>
                      </a:r>
                    </a:p>
                  </a:txBody>
                  <a:tcPr marL="3563" marR="3563" marT="9151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(36)</a:t>
                      </a:r>
                    </a:p>
                  </a:txBody>
                  <a:tcPr marL="0" marR="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35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8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 (24.5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 (25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4">
                  <a:txBody>
                    <a:bodyPr/>
                    <a:lstStyle/>
                    <a:p>
                      <a:pPr marL="0" marR="0" lvl="0" indent="0" algn="ctr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 (43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(78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1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24656873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 (29)</a:t>
                      </a:r>
                    </a:p>
                  </a:txBody>
                  <a:tcPr marL="3563" marR="3563" marT="9151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33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35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 (24.5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 (28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ctr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 (35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11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ctr" defTabSz="1072866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43867591"/>
                  </a:ext>
                </a:extLst>
              </a:tr>
              <a:tr h="122584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 (21)</a:t>
                      </a:r>
                    </a:p>
                  </a:txBody>
                  <a:tcPr marL="3563" marR="3563" marT="9151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17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18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 (30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 (28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(19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11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ctr" defTabSz="1072866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53649885"/>
                  </a:ext>
                </a:extLst>
              </a:tr>
              <a:tr h="122584">
                <a:tc vMerge="1">
                  <a:txBody>
                    <a:bodyPr/>
                    <a:lstStyle/>
                    <a:p>
                      <a:pPr algn="l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 dirty="0">
                        <a:effectLst/>
                        <a:latin typeface="+mn-lt"/>
                      </a:endParaRPr>
                    </a:p>
                  </a:txBody>
                  <a:tcPr marL="3563" marR="3563" marT="35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or more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10)</a:t>
                      </a:r>
                    </a:p>
                  </a:txBody>
                  <a:tcPr marL="3563" marR="3563" marT="9151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11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12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 (21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 (19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3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ctr" defTabSz="1072866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6013518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 dirty="0">
                        <a:effectLst/>
                        <a:latin typeface="+mn-lt"/>
                      </a:endParaRPr>
                    </a:p>
                  </a:txBody>
                  <a:tcPr marL="34211" marR="34211" marT="17106" marB="171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9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orbidities–no(%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212" marR="34212" marT="17107" marB="1710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PD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6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8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13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9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3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 (16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(24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9">
                  <a:txBody>
                    <a:bodyPr/>
                    <a:lstStyle/>
                    <a:p>
                      <a:pPr marL="0" marR="0" lvl="0" indent="0" algn="ctr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1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8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9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 (38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29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9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9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49759606"/>
                  </a:ext>
                </a:extLst>
              </a:tr>
              <a:tr h="122584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MI ≥ 30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 (21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23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20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 (14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 (18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16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(16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12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63340574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ertension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 (58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 (69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(47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16150336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43481492"/>
                  </a:ext>
                </a:extLst>
              </a:tr>
              <a:tr h="122584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1072731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fr-FR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7 (52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1072731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fr-FR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8 (56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algn="ctr" defTabSz="1072731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fr-FR" sz="800" b="0" i="0" u="none" strike="noStrike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1072731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4 (38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1072731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 (11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82038454"/>
                  </a:ext>
                </a:extLst>
              </a:tr>
              <a:tr h="122584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F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6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7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algn="ctr" defTabSz="1072731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fr-FR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6 (40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algn="ctr" defTabSz="1072731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fr-FR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3 (27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algn="ctr" defTabSz="1072731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fr-FR" sz="800" b="0" i="0" u="none" strike="noStrike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algn="ctr" defTabSz="1072731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algn="ctr" defTabSz="1072731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 (39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(41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52078036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M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9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13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1980386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algn="ctr" defTabSz="1072731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5 (28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algn="ctr" defTabSz="1072731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8 (21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algn="ctr" defTabSz="1072731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algn="ctr" defTabSz="1072731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8 (22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algn="ctr" defTabSz="1072731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 (22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13786882"/>
                  </a:ext>
                </a:extLst>
              </a:tr>
              <a:tr h="122584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 (18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 (53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46959270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 dirty="0">
                        <a:effectLst/>
                        <a:latin typeface="+mn-lt"/>
                      </a:endParaRPr>
                    </a:p>
                  </a:txBody>
                  <a:tcPr marL="34211" marR="34211" marT="17106" marB="171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3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ype of cancer–no(%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212" marR="34212" marT="17107" marB="1710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 (80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 (94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 (67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 (79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 (73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0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 (81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(78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3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 (80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 (65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2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03934065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 dirty="0">
                        <a:effectLst/>
                        <a:latin typeface="+mn-lt"/>
                      </a:endParaRPr>
                    </a:p>
                  </a:txBody>
                  <a:tcPr marL="34211" marR="34211" marT="17106" marB="171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211" marR="34211" marT="17106" marB="171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(20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6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33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 (13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 (18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ctr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0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(19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22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(20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35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08786503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212" marR="34212" marT="17107" marB="1710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known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0" i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(8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(9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0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54929897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 dirty="0">
                        <a:effectLst/>
                        <a:latin typeface="+mn-lt"/>
                      </a:endParaRPr>
                    </a:p>
                  </a:txBody>
                  <a:tcPr marL="34211" marR="34211" marT="17106" marB="171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4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ncer spread</a:t>
                      </a:r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–no(%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212" marR="34212" marT="17107" marB="1710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calized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 (33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9151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24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22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4">
                  <a:txBody>
                    <a:bodyPr/>
                    <a:lstStyle/>
                    <a:p>
                      <a:pPr marL="0" marR="0" lvl="0" indent="0" algn="ctr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13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ctr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1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 (31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(41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0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78449893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cally advanced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 (21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9151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(47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6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11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11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6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12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2528460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astatic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 (46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9151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29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 (72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 (12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(9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5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 (76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(88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 (35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35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64468038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211" marR="34211" marT="17106" marB="171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known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 (88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 (91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 (29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12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02008968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 dirty="0">
                        <a:effectLst/>
                        <a:latin typeface="+mn-lt"/>
                      </a:endParaRPr>
                    </a:p>
                  </a:txBody>
                  <a:tcPr marL="21382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4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ncer status–no(%)</a:t>
                      </a:r>
                      <a:endParaRPr lang="en-US" sz="8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1382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mission or NED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 (42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9151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(41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28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ctr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16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11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2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 (35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29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6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35943140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>
                        <a:effectLst/>
                        <a:latin typeface="+mn-lt"/>
                      </a:endParaRPr>
                    </a:p>
                  </a:txBody>
                  <a:tcPr marL="21382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/PR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 (27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9151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35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(39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ctr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0" i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(19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22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12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18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35491901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 dirty="0">
                        <a:effectLst/>
                        <a:latin typeface="+mn-lt"/>
                      </a:endParaRPr>
                    </a:p>
                  </a:txBody>
                  <a:tcPr marL="21382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 (31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9151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24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33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ctr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0" i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 (65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67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12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18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2527235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1382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1072866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known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0" i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(41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35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96734805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 dirty="0">
                        <a:effectLst/>
                        <a:latin typeface="+mn-lt"/>
                      </a:endParaRPr>
                    </a:p>
                  </a:txBody>
                  <a:tcPr marL="34211" marR="34211" marT="17106" marB="171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4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COG PS–no(%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212" marR="34212" marT="17107" marB="1710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 (33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9151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(47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28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7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4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 (43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22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ctr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5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 (22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29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3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87949805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 (44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9151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(41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33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 (35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56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 (39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18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47859117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or more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 (23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9151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12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(39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(22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22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 (27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 (53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09959016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211" marR="34211" marT="17106" marB="171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1072866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known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12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44595627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 dirty="0">
                        <a:effectLst/>
                        <a:latin typeface="+mn-lt"/>
                      </a:endParaRPr>
                    </a:p>
                  </a:txBody>
                  <a:tcPr marL="21382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7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cancer therapy–no(%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1382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e*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 (61)</a:t>
                      </a:r>
                    </a:p>
                  </a:txBody>
                  <a:tcPr marL="3563" marR="3563" marT="9151" marB="0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 (82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 (67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9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7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 (38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33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0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 (53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(47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69226186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 dirty="0">
                        <a:effectLst/>
                        <a:latin typeface="+mn-lt"/>
                      </a:endParaRPr>
                    </a:p>
                  </a:txBody>
                  <a:tcPr marL="21382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1382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emotherapy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(15)</a:t>
                      </a:r>
                    </a:p>
                  </a:txBody>
                  <a:tcPr marL="3563" marR="3563" marT="9151" marB="0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12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22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 rowSpan="6">
                  <a:txBody>
                    <a:bodyPr/>
                    <a:lstStyle/>
                    <a:p>
                      <a:pPr marL="0" marR="0" lvl="0" indent="0" algn="ctr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0" i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 (38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44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6">
                  <a:txBody>
                    <a:bodyPr/>
                    <a:lstStyle/>
                    <a:p>
                      <a:pPr marL="0" marR="0" lvl="0" indent="0" algn="ctr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0" i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 (24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24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6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1967611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 dirty="0">
                        <a:effectLst/>
                        <a:latin typeface="+mn-lt"/>
                      </a:endParaRPr>
                    </a:p>
                  </a:txBody>
                  <a:tcPr marL="21382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1382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diotherapy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2)</a:t>
                      </a:r>
                    </a:p>
                  </a:txBody>
                  <a:tcPr marL="3563" marR="3563" marT="9151" marB="0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3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11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36017390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 dirty="0">
                        <a:effectLst/>
                        <a:latin typeface="+mn-lt"/>
                      </a:endParaRPr>
                    </a:p>
                  </a:txBody>
                  <a:tcPr marL="21382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1382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rgery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4)</a:t>
                      </a:r>
                    </a:p>
                  </a:txBody>
                  <a:tcPr marL="3563" marR="3563" marT="9151" marB="0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6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6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6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2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4220956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 dirty="0">
                        <a:effectLst/>
                        <a:latin typeface="+mn-lt"/>
                      </a:endParaRPr>
                    </a:p>
                  </a:txBody>
                  <a:tcPr marL="21382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1382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T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3 (6)</a:t>
                      </a:r>
                    </a:p>
                  </a:txBody>
                  <a:tcPr marL="3563" marR="3563" marT="9151" marB="0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11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4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6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33677725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 dirty="0">
                        <a:effectLst/>
                        <a:latin typeface="+mn-lt"/>
                      </a:endParaRPr>
                    </a:p>
                  </a:txBody>
                  <a:tcPr marL="21382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1382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munotherapy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()</a:t>
                      </a:r>
                    </a:p>
                  </a:txBody>
                  <a:tcPr marL="3563" marR="3563" marT="9151" marB="0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6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22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4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18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35037466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 dirty="0">
                        <a:effectLst/>
                        <a:latin typeface="+mn-lt"/>
                      </a:endParaRPr>
                    </a:p>
                  </a:txBody>
                  <a:tcPr marL="21382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1382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hers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8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56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11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12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11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12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6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 dirty="0">
                        <a:effectLst/>
                        <a:latin typeface="+mn-lt"/>
                      </a:endParaRPr>
                    </a:p>
                  </a:txBody>
                  <a:tcPr marL="21382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inical course–no(%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1382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hospital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 (27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9151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(59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11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ctr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1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 (38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33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9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8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12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7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53424291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 dirty="0">
                        <a:effectLst/>
                        <a:latin typeface="+mn-lt"/>
                      </a:endParaRPr>
                    </a:p>
                  </a:txBody>
                  <a:tcPr marL="3563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ospitalization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 (61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9151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23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 (83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 (63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56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 (90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 (88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82417291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 dirty="0">
                        <a:effectLst/>
                        <a:latin typeface="+mn-lt"/>
                      </a:endParaRPr>
                    </a:p>
                  </a:txBody>
                  <a:tcPr marL="3563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U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11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9151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18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6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 (10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 (22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11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2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85320412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 dirty="0">
                        <a:effectLst/>
                        <a:latin typeface="+mn-lt"/>
                      </a:endParaRPr>
                    </a:p>
                  </a:txBody>
                  <a:tcPr marL="21382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ath-–no(%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1382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7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18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2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6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5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0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(19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33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8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6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6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92958256"/>
                  </a:ext>
                </a:extLst>
              </a:tr>
              <a:tr h="436086">
                <a:tc rowSpan="5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ral characteristics</a:t>
                      </a:r>
                    </a:p>
                  </a:txBody>
                  <a:tcPr marL="21382" marR="3563" marT="3563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valuable Ct</a:t>
                      </a: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–</a:t>
                      </a:r>
                      <a:r>
                        <a:rPr lang="en-US" sz="8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(%)</a:t>
                      </a:r>
                    </a:p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Ct (range)</a:t>
                      </a:r>
                    </a:p>
                  </a:txBody>
                  <a:tcPr marL="21382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0 </a:t>
                      </a:r>
                    </a:p>
                  </a:txBody>
                  <a:tcPr marL="3563" marR="3563" marT="3563" marB="0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 (71)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1-36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 (76)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20-36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 (67)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-30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6</a:t>
                      </a:r>
                      <a:r>
                        <a:rPr lang="en-US" sz="800" b="0" i="1" u="none" strike="noStrike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</a:t>
                      </a:r>
                      <a:endParaRPr lang="en-US" sz="800" b="0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 (76)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6-34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 (78)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2-34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1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 (41)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19-33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56)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 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3-31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</a:t>
                      </a:r>
                      <a:r>
                        <a:rPr lang="en-US" sz="800" b="0" i="1" u="none" strike="noStrike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</a:t>
                      </a:r>
                      <a:endParaRPr lang="en-US" sz="800" b="1" i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5"/>
                  </a:ext>
                </a:extLst>
              </a:tr>
              <a:tr h="122584">
                <a:tc vMerge="1"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b="1" i="0" u="none" strike="noStrike" dirty="0">
                        <a:effectLst/>
                        <a:latin typeface="+mn-lt"/>
                      </a:endParaRPr>
                    </a:p>
                  </a:txBody>
                  <a:tcPr marL="21382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rowSpan="4">
                  <a:txBody>
                    <a:bodyPr/>
                    <a:lstStyle/>
                    <a:p>
                      <a:pPr marL="0" marR="0" lvl="0" indent="0" algn="l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reatment </a:t>
                      </a: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–</a:t>
                      </a:r>
                      <a:r>
                        <a:rPr lang="en-US" sz="8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(%)</a:t>
                      </a:r>
                    </a:p>
                    <a:p>
                      <a:pPr marL="0" algn="l" defTabSz="1072731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1" i="0" u="none" strike="noStrike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382" marR="3563" marT="3563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fr-FR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CQ</a:t>
                      </a:r>
                      <a:endParaRPr lang="en-US" sz="8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 (60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 (74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ctr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1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6"/>
                  </a:ext>
                </a:extLst>
              </a:tr>
              <a:tr h="122584">
                <a:tc vMerge="1"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b="1" i="0" u="none" strike="noStrike" dirty="0">
                        <a:effectLst/>
                        <a:latin typeface="+mn-lt"/>
                      </a:endParaRPr>
                    </a:p>
                  </a:txBody>
                  <a:tcPr marL="21382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1382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fr-FR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ZI</a:t>
                      </a:r>
                      <a:endParaRPr lang="en-US" sz="8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 (94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 (96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7"/>
                  </a:ext>
                </a:extLst>
              </a:tr>
              <a:tr h="122584">
                <a:tc vMerge="1"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b="1" i="0" u="none" strike="noStrike" dirty="0">
                        <a:effectLst/>
                        <a:latin typeface="+mn-lt"/>
                      </a:endParaRPr>
                    </a:p>
                  </a:txBody>
                  <a:tcPr marL="21382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1382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CQ+AZI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 (37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18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(39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 (58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 (73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13)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11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4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8"/>
                  </a:ext>
                </a:extLst>
              </a:tr>
              <a:tr h="155516">
                <a:tc vMerge="1"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b="1" i="0" u="none" strike="noStrike" dirty="0">
                        <a:effectLst/>
                        <a:latin typeface="+mn-lt"/>
                      </a:endParaRPr>
                    </a:p>
                  </a:txBody>
                  <a:tcPr marL="21382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1382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algn="l" defTabSz="1072731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i="0" u="none" strike="noStrike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algn="l" defTabSz="1072731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1" i="0" u="none" strike="noStrike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algn="l" defTabSz="1072731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1" i="0" u="none" strike="noStrike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algn="l" defTabSz="1072731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1" i="0" u="none" strike="noStrike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algn="l" defTabSz="1072731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1" i="0" u="none" strike="noStrike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algn="l" defTabSz="1072731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1" i="0" u="none" strike="noStrike" kern="1200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algn="l" defTabSz="1072731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1" i="0" u="none" strike="noStrike" kern="1200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6186931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27C427CC-6287-4B76-B53E-90C90DDEDC3C}"/>
              </a:ext>
            </a:extLst>
          </p:cNvPr>
          <p:cNvSpPr txBox="1"/>
          <p:nvPr/>
        </p:nvSpPr>
        <p:spPr>
          <a:xfrm>
            <a:off x="0" y="618063"/>
            <a:ext cx="685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able S2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linical characteristics of Cancer_FR1 available for translational research</a:t>
            </a:r>
          </a:p>
        </p:txBody>
      </p:sp>
      <p:graphicFrame>
        <p:nvGraphicFramePr>
          <p:cNvPr id="6" name="Table 3">
            <a:extLst>
              <a:ext uri="{FF2B5EF4-FFF2-40B4-BE49-F238E27FC236}">
                <a16:creationId xmlns:a16="http://schemas.microsoft.com/office/drawing/2014/main" id="{B55FFE82-9141-4CCB-99A7-46A1EA86150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02077307"/>
              </p:ext>
            </p:extLst>
          </p:nvPr>
        </p:nvGraphicFramePr>
        <p:xfrm>
          <a:off x="106091" y="1055857"/>
          <a:ext cx="6633356" cy="5634882"/>
        </p:xfrm>
        <a:graphic>
          <a:graphicData uri="http://schemas.openxmlformats.org/drawingml/2006/table">
            <a:tbl>
              <a:tblPr/>
              <a:tblGrid>
                <a:gridCol w="15459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87701">
                  <a:extLst>
                    <a:ext uri="{9D8B030D-6E8A-4147-A177-3AD203B41FA5}">
                      <a16:colId xmlns:a16="http://schemas.microsoft.com/office/drawing/2014/main" val="998469083"/>
                    </a:ext>
                  </a:extLst>
                </a:gridCol>
                <a:gridCol w="956440">
                  <a:extLst>
                    <a:ext uri="{9D8B030D-6E8A-4147-A177-3AD203B41FA5}">
                      <a16:colId xmlns:a16="http://schemas.microsoft.com/office/drawing/2014/main" val="2275575751"/>
                    </a:ext>
                  </a:extLst>
                </a:gridCol>
                <a:gridCol w="765153">
                  <a:extLst>
                    <a:ext uri="{9D8B030D-6E8A-4147-A177-3AD203B41FA5}">
                      <a16:colId xmlns:a16="http://schemas.microsoft.com/office/drawing/2014/main" val="2129753739"/>
                    </a:ext>
                  </a:extLst>
                </a:gridCol>
                <a:gridCol w="828916">
                  <a:extLst>
                    <a:ext uri="{9D8B030D-6E8A-4147-A177-3AD203B41FA5}">
                      <a16:colId xmlns:a16="http://schemas.microsoft.com/office/drawing/2014/main" val="3936874366"/>
                    </a:ext>
                  </a:extLst>
                </a:gridCol>
                <a:gridCol w="890788">
                  <a:extLst>
                    <a:ext uri="{9D8B030D-6E8A-4147-A177-3AD203B41FA5}">
                      <a16:colId xmlns:a16="http://schemas.microsoft.com/office/drawing/2014/main" val="2198652549"/>
                    </a:ext>
                  </a:extLst>
                </a:gridCol>
                <a:gridCol w="650969">
                  <a:extLst>
                    <a:ext uri="{9D8B030D-6E8A-4147-A177-3AD203B41FA5}">
                      <a16:colId xmlns:a16="http://schemas.microsoft.com/office/drawing/2014/main" val="3850000648"/>
                    </a:ext>
                  </a:extLst>
                </a:gridCol>
                <a:gridCol w="549398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549398">
                  <a:extLst>
                    <a:ext uri="{9D8B030D-6E8A-4147-A177-3AD203B41FA5}">
                      <a16:colId xmlns:a16="http://schemas.microsoft.com/office/drawing/2014/main" val="723810324"/>
                    </a:ext>
                  </a:extLst>
                </a:gridCol>
              </a:tblGrid>
              <a:tr h="355409">
                <a:tc rowSpan="2" gridSpan="3"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’s characteristics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212" marR="34212" marT="17107" marB="17107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rowSpan="2" hMerge="1"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 dirty="0">
                        <a:effectLst/>
                        <a:latin typeface="+mn-lt"/>
                      </a:endParaRPr>
                    </a:p>
                  </a:txBody>
                  <a:tcPr marL="34211" marR="34211" marT="17106" marB="17106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s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43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gridSpan="4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VID-19</a:t>
                      </a:r>
                      <a:r>
                        <a:rPr lang="en-US" sz="800" b="1" i="0" u="none" strike="noStrike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VID+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indent="0" algn="ctr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covery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40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94357318"/>
                  </a:ext>
                </a:extLst>
              </a:tr>
              <a:tr h="294094">
                <a:tc gridSpan="3" vMerge="1"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212" marR="34212" marT="17107" marB="17107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VS+LVS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25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VS 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10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VS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15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56502313"/>
                  </a:ext>
                </a:extLst>
              </a:tr>
              <a:tr h="241687">
                <a:tc rowSpan="37"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inical</a:t>
                      </a:r>
                      <a:r>
                        <a:rPr lang="en-US" sz="800" b="1" i="0" u="none" strike="noStrike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haracteristics</a:t>
                      </a:r>
                      <a:endParaRPr lang="en-US" sz="8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1382" marR="3563" marT="3563" marB="0" vert="vert27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(year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1382" marR="3563" marT="35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</a:t>
                      </a:r>
                    </a:p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range)</a:t>
                      </a:r>
                      <a:endParaRPr lang="en-US" sz="8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 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33-82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31-89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31-62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39-89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,5 </a:t>
                      </a:r>
                    </a:p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31-89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66745699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 dirty="0">
                        <a:effectLst/>
                        <a:latin typeface="+mn-lt"/>
                      </a:endParaRPr>
                    </a:p>
                  </a:txBody>
                  <a:tcPr marL="34211" marR="34211" marT="17106" marB="171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der</a:t>
                      </a:r>
                    </a:p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–no(%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212" marR="34212" marT="17107" marB="1710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 </a:t>
                      </a:r>
                      <a:endParaRPr lang="en-US" sz="8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 (42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 (36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40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33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3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 (38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16454267"/>
                  </a:ext>
                </a:extLst>
              </a:tr>
              <a:tr h="178108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male</a:t>
                      </a:r>
                      <a:endParaRPr lang="en-US" sz="8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 (58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 (64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60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(67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 (62)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4809223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 dirty="0">
                        <a:effectLst/>
                        <a:latin typeface="+mn-lt"/>
                      </a:endParaRPr>
                    </a:p>
                  </a:txBody>
                  <a:tcPr marL="34211" marR="34211" marT="17106" marB="171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5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of comorbidities–no(%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212" marR="34212" marT="17107" marB="1710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 (30)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(40)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50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33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5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 (40)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24656873"/>
                  </a:ext>
                </a:extLst>
              </a:tr>
              <a:tr h="7902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 (39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24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10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33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43867591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 (33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22584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(16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24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20) 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27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(17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53649885"/>
                  </a:ext>
                </a:extLst>
              </a:tr>
              <a:tr h="122584">
                <a:tc vMerge="1">
                  <a:txBody>
                    <a:bodyPr/>
                    <a:lstStyle/>
                    <a:p>
                      <a:pPr algn="l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 dirty="0">
                        <a:effectLst/>
                        <a:latin typeface="+mn-lt"/>
                      </a:endParaRPr>
                    </a:p>
                  </a:txBody>
                  <a:tcPr marL="3563" marR="3563" marT="35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or more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14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12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20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7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10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6013518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 dirty="0">
                        <a:effectLst/>
                        <a:latin typeface="+mn-lt"/>
                      </a:endParaRPr>
                    </a:p>
                  </a:txBody>
                  <a:tcPr marL="34211" marR="34211" marT="17106" marB="171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5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orbidities–no(%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212" marR="34212" marT="17107" marB="1710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PD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9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8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10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7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5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0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8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49759606"/>
                  </a:ext>
                </a:extLst>
              </a:tr>
              <a:tr h="122584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MI ≥ 30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(16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24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30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20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(25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63340574"/>
                  </a:ext>
                </a:extLst>
              </a:tr>
              <a:tr h="122584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ertension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(46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(40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40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40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 (42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16150336"/>
                  </a:ext>
                </a:extLst>
              </a:tr>
              <a:tr h="122584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F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5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4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(0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7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2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52078036"/>
                  </a:ext>
                </a:extLst>
              </a:tr>
              <a:tr h="122584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M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r>
                        <a:rPr lang="en-US" sz="800" b="0" i="0" u="none" strike="noStrike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12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12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10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13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8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1980386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 dirty="0">
                        <a:effectLst/>
                        <a:latin typeface="+mn-lt"/>
                      </a:endParaRPr>
                    </a:p>
                  </a:txBody>
                  <a:tcPr marL="34211" marR="34211" marT="17106" marB="171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ype of cancer–no(%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212" marR="34212" marT="17107" marB="1710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 (93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 (72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 (90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 (60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0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 (85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03934065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 dirty="0">
                        <a:effectLst/>
                        <a:latin typeface="+mn-lt"/>
                      </a:endParaRPr>
                    </a:p>
                  </a:txBody>
                  <a:tcPr marL="34211" marR="34211" marT="17106" marB="171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211" marR="34211" marT="17106" marB="171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7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(28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10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40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15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08786503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 dirty="0">
                        <a:effectLst/>
                        <a:latin typeface="+mn-lt"/>
                      </a:endParaRPr>
                    </a:p>
                  </a:txBody>
                  <a:tcPr marL="34211" marR="34211" marT="17106" marB="171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ncer spread</a:t>
                      </a:r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–no(%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212" marR="34212" marT="17107" marB="1710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calized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 (35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24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30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20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8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 (35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78449893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cally advanced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 (28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16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30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7) 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 (23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2528460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astatic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 (37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 (60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40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 (73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 (42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64468038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 dirty="0">
                        <a:effectLst/>
                        <a:latin typeface="+mn-lt"/>
                      </a:endParaRPr>
                    </a:p>
                  </a:txBody>
                  <a:tcPr marL="21382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3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ncer status–no(%)</a:t>
                      </a:r>
                      <a:endParaRPr lang="en-US" sz="8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1382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mission or NED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r>
                        <a:rPr lang="en-US" sz="800" b="0" i="0" u="none" strike="noStrike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23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(40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50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33.3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 (53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35943140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>
                        <a:effectLst/>
                        <a:latin typeface="+mn-lt"/>
                      </a:endParaRPr>
                    </a:p>
                  </a:txBody>
                  <a:tcPr marL="21382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/PR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 (21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(32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30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33.3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15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35491901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 dirty="0">
                        <a:effectLst/>
                        <a:latin typeface="+mn-lt"/>
                      </a:endParaRPr>
                    </a:p>
                  </a:txBody>
                  <a:tcPr marL="21382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 (56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(28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20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33.3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 (33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2527235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 dirty="0">
                        <a:effectLst/>
                        <a:latin typeface="+mn-lt"/>
                      </a:endParaRPr>
                    </a:p>
                  </a:txBody>
                  <a:tcPr marL="34211" marR="34211" marT="17106" marB="171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COG PS–no(%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212" marR="34212" marT="17107" marB="1710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 (60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(32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30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33.3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 (40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87949805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 (33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(40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50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33.3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 (33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47859117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or more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7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(28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20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33.3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(25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09959016"/>
                  </a:ext>
                </a:extLst>
              </a:tr>
              <a:tr h="240951"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 dirty="0">
                        <a:effectLst/>
                        <a:latin typeface="+mn-lt"/>
                      </a:endParaRPr>
                    </a:p>
                  </a:txBody>
                  <a:tcPr marL="21382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9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cancer therapy–no(%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1382" marR="3563" marT="3563" marB="0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e*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 (65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 (72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 (90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 (60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0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 (85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69226186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>
                    <a:lnT w="12700" cmpd="sng">
                      <a:noFill/>
                      <a:prstDash val="solid"/>
                    </a:lnT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>
                    <a:lnT w="12700" cmpd="sng">
                      <a:noFill/>
                      <a:prstDash val="solid"/>
                    </a:lnT>
                  </a:tcPr>
                </a:tc>
                <a:tc rowSpan="3"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emotherapy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3"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(19)</a:t>
                      </a:r>
                      <a:endParaRPr lang="fr-FR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20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10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3"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27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8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mpd="sng">
                      <a:noFill/>
                      <a:prstDash val="soli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>
                    <a:lnT w="12700" cmpd="sng">
                      <a:noFill/>
                      <a:prstDash val="solid"/>
                    </a:lnT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>
                    <a:lnT w="12700" cmpd="sng">
                      <a:noFill/>
                      <a:prstDash val="solid"/>
                    </a:lnT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>
                    <a:lnT w="12700" cmpd="sng">
                      <a:noFill/>
                      <a:prstDash val="solid"/>
                    </a:lnT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>
                    <a:lnT w="12700" cmpd="sng">
                      <a:noFill/>
                      <a:prstDash val="solid"/>
                    </a:lnT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>
                    <a:lnT w="12700" cmpd="sng">
                      <a:noFill/>
                      <a:prstDash val="solid"/>
                    </a:lnT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10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3331201"/>
                  </a:ext>
                </a:extLst>
              </a:tr>
              <a:tr h="90541"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 dirty="0">
                        <a:effectLst/>
                        <a:latin typeface="+mn-lt"/>
                      </a:endParaRPr>
                    </a:p>
                  </a:txBody>
                  <a:tcPr marL="21382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1382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indent="0" algn="ctr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indent="0" algn="ctr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36017390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diotherapy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14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107565"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 dirty="0">
                        <a:effectLst/>
                        <a:latin typeface="+mn-lt"/>
                      </a:endParaRPr>
                    </a:p>
                  </a:txBody>
                  <a:tcPr marL="21382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1382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rgery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4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(0)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6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4220956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 dirty="0">
                        <a:effectLst/>
                        <a:latin typeface="+mn-lt"/>
                      </a:endParaRPr>
                    </a:p>
                  </a:txBody>
                  <a:tcPr marL="21382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1382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ormonal therapy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2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8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13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2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33677725"/>
                  </a:ext>
                </a:extLst>
              </a:tr>
              <a:tr h="53783"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 dirty="0">
                        <a:effectLst/>
                        <a:latin typeface="+mn-lt"/>
                      </a:endParaRPr>
                    </a:p>
                  </a:txBody>
                  <a:tcPr marL="21382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1382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munotherapy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7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35037466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 dirty="0">
                        <a:effectLst/>
                        <a:latin typeface="+mn-lt"/>
                      </a:endParaRPr>
                    </a:p>
                  </a:txBody>
                  <a:tcPr marL="21382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1382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hers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2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12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10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13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10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 dirty="0">
                        <a:effectLst/>
                        <a:latin typeface="+mn-lt"/>
                      </a:endParaRPr>
                    </a:p>
                  </a:txBody>
                  <a:tcPr marL="21382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inical course–no(%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1382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hospital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 (77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(28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50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13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 (33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53424291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 dirty="0">
                        <a:effectLst/>
                        <a:latin typeface="+mn-lt"/>
                      </a:endParaRPr>
                    </a:p>
                  </a:txBody>
                  <a:tcPr marL="3563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ospitalization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(23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 (60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30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 (80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 (55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82417291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 dirty="0">
                        <a:effectLst/>
                        <a:latin typeface="+mn-lt"/>
                      </a:endParaRPr>
                    </a:p>
                  </a:txBody>
                  <a:tcPr marL="3563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l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U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107273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12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20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7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12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85320412"/>
                  </a:ext>
                </a:extLst>
              </a:tr>
              <a:tr h="137004">
                <a:tc vMerge="1"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0" u="none" strike="noStrike" dirty="0">
                        <a:effectLst/>
                        <a:latin typeface="+mn-lt"/>
                      </a:endParaRPr>
                    </a:p>
                  </a:txBody>
                  <a:tcPr marL="21382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ath-–no(%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1382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r>
                        <a:rPr lang="en-US" sz="800" b="0" i="0" u="none" strike="noStrike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12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8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13)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</a:t>
                      </a:r>
                    </a:p>
                  </a:txBody>
                  <a:tcPr marL="3563" marR="3563" marT="3563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2)</a:t>
                      </a:r>
                    </a:p>
                  </a:txBody>
                  <a:tcPr marL="3563" marR="3563" marT="3563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92958256"/>
                  </a:ext>
                </a:extLst>
              </a:tr>
            </a:tbl>
          </a:graphicData>
        </a:graphic>
      </p:graphicFrame>
      <p:sp>
        <p:nvSpPr>
          <p:cNvPr id="5" name="ZoneTexte 4">
            <a:extLst>
              <a:ext uri="{FF2B5EF4-FFF2-40B4-BE49-F238E27FC236}">
                <a16:creationId xmlns:a16="http://schemas.microsoft.com/office/drawing/2014/main" id="{74444329-0CA2-4226-9FA7-83AA7248664C}"/>
              </a:ext>
            </a:extLst>
          </p:cNvPr>
          <p:cNvSpPr txBox="1"/>
          <p:nvPr/>
        </p:nvSpPr>
        <p:spPr>
          <a:xfrm>
            <a:off x="19832" y="6744489"/>
            <a:ext cx="68580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MI: Body Mass Index; </a:t>
            </a:r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F: Congestive heart failure;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OPD: Chronic Obstructive Pulmonary Disease; H: Hematological malignancies; DM: Diabetes mellitus;</a:t>
            </a:r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CU: Intensive Care Unit; LVS: Long Viral Shedding; NED: No Evidence of Disease; no: number; PD: Progressive Disease; PS: Performance Status; S: Solid tumors; SD/PR: Stable Disease/Partial Response; SVS: Short Viral Shedding; *</a:t>
            </a:r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 the 4 weeks before inclusion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tatistical analyses: Mann-Whitney</a:t>
            </a:r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, Chi-Square or Fisher’s exact tests.</a:t>
            </a:r>
          </a:p>
        </p:txBody>
      </p:sp>
    </p:spTree>
    <p:extLst>
      <p:ext uri="{BB962C8B-B14F-4D97-AF65-F5344CB8AC3E}">
        <p14:creationId xmlns:p14="http://schemas.microsoft.com/office/powerpoint/2010/main" val="415490172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713</TotalTime>
  <Words>2603</Words>
  <Application>Microsoft Office PowerPoint</Application>
  <PresentationFormat>Format A4 (210 x 297 mm)</PresentationFormat>
  <Paragraphs>795</Paragraphs>
  <Slides>2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5" baseType="lpstr">
      <vt:lpstr>Arial</vt:lpstr>
      <vt:lpstr>Calibri</vt:lpstr>
      <vt:lpstr>Thème Office</vt:lpstr>
      <vt:lpstr>Présentation PowerPoint</vt:lpstr>
      <vt:lpstr>Présentation PowerPoint</vt:lpstr>
    </vt:vector>
  </TitlesOfParts>
  <Company>Institut Gustave ROUSS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DEROSA Lisa</dc:creator>
  <cp:lastModifiedBy>Anne-Gaelle Goubet</cp:lastModifiedBy>
  <cp:revision>215</cp:revision>
  <cp:lastPrinted>2020-09-08T11:36:10Z</cp:lastPrinted>
  <dcterms:created xsi:type="dcterms:W3CDTF">2020-09-07T14:14:20Z</dcterms:created>
  <dcterms:modified xsi:type="dcterms:W3CDTF">2021-01-23T15:36:00Z</dcterms:modified>
</cp:coreProperties>
</file>